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97" r:id="rId2"/>
  </p:sldIdLst>
  <p:sldSz cx="6858000" cy="9906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99"/>
    <a:srgbClr val="FF2F2F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淡色スタイル 3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26" autoAdjust="0"/>
    <p:restoredTop sz="94660"/>
  </p:normalViewPr>
  <p:slideViewPr>
    <p:cSldViewPr snapToGrid="0">
      <p:cViewPr>
        <p:scale>
          <a:sx n="100" d="100"/>
          <a:sy n="100" d="100"/>
        </p:scale>
        <p:origin x="870" y="-6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533C3-B4AF-4F3E-B03E-43D86121D566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48E36-BA7A-4E66-AB2A-BB6F59BC62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06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533C3-B4AF-4F3E-B03E-43D86121D566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48E36-BA7A-4E66-AB2A-BB6F59BC62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8137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533C3-B4AF-4F3E-B03E-43D86121D566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48E36-BA7A-4E66-AB2A-BB6F59BC62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82707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533C3-B4AF-4F3E-B03E-43D86121D566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48E36-BA7A-4E66-AB2A-BB6F59BC62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4303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533C3-B4AF-4F3E-B03E-43D86121D566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48E36-BA7A-4E66-AB2A-BB6F59BC62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0094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533C3-B4AF-4F3E-B03E-43D86121D566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48E36-BA7A-4E66-AB2A-BB6F59BC62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5627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533C3-B4AF-4F3E-B03E-43D86121D566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48E36-BA7A-4E66-AB2A-BB6F59BC62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9895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533C3-B4AF-4F3E-B03E-43D86121D566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48E36-BA7A-4E66-AB2A-BB6F59BC62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109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533C3-B4AF-4F3E-B03E-43D86121D566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48E36-BA7A-4E66-AB2A-BB6F59BC62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706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533C3-B4AF-4F3E-B03E-43D86121D566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48E36-BA7A-4E66-AB2A-BB6F59BC62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0409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533C3-B4AF-4F3E-B03E-43D86121D566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48E36-BA7A-4E66-AB2A-BB6F59BC62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9424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8533C3-B4AF-4F3E-B03E-43D86121D566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C48E36-BA7A-4E66-AB2A-BB6F59BC62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4437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F7F682F5-E810-4F8C-93F6-1E935DB5736F}"/>
              </a:ext>
            </a:extLst>
          </p:cNvPr>
          <p:cNvGrpSpPr/>
          <p:nvPr/>
        </p:nvGrpSpPr>
        <p:grpSpPr>
          <a:xfrm>
            <a:off x="1739550" y="1229160"/>
            <a:ext cx="3778168" cy="3306610"/>
            <a:chOff x="1815750" y="2143560"/>
            <a:chExt cx="3778168" cy="3306610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20D35382-8AB1-41FA-A8D4-E626058E46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58" t="20270" r="59504" b="15967"/>
            <a:stretch/>
          </p:blipFill>
          <p:spPr>
            <a:xfrm>
              <a:off x="1821772" y="2926046"/>
              <a:ext cx="923925" cy="2492291"/>
            </a:xfrm>
            <a:prstGeom prst="rect">
              <a:avLst/>
            </a:prstGeom>
          </p:spPr>
        </p:pic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ACA1A573-A91F-48AF-A1D5-F4B455AF7938}"/>
                </a:ext>
              </a:extLst>
            </p:cNvPr>
            <p:cNvCxnSpPr/>
            <p:nvPr/>
          </p:nvCxnSpPr>
          <p:spPr>
            <a:xfrm>
              <a:off x="2774272" y="3602321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id="{D90B9F87-AB58-4FBD-8055-D4C0B07B0271}"/>
                </a:ext>
              </a:extLst>
            </p:cNvPr>
            <p:cNvCxnSpPr/>
            <p:nvPr/>
          </p:nvCxnSpPr>
          <p:spPr>
            <a:xfrm>
              <a:off x="2774272" y="3926171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591D0986-4C23-445D-A95B-488C4BC1B82A}"/>
                </a:ext>
              </a:extLst>
            </p:cNvPr>
            <p:cNvCxnSpPr/>
            <p:nvPr/>
          </p:nvCxnSpPr>
          <p:spPr>
            <a:xfrm>
              <a:off x="2774272" y="4535771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D709D85C-AFD4-45BC-A887-1522DFB57D77}"/>
                </a:ext>
              </a:extLst>
            </p:cNvPr>
            <p:cNvSpPr txBox="1"/>
            <p:nvPr/>
          </p:nvSpPr>
          <p:spPr>
            <a:xfrm>
              <a:off x="2903455" y="3463821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0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35179F87-EAA3-4E97-BC8D-3695E36EBCEE}"/>
                </a:ext>
              </a:extLst>
            </p:cNvPr>
            <p:cNvSpPr txBox="1"/>
            <p:nvPr/>
          </p:nvSpPr>
          <p:spPr>
            <a:xfrm>
              <a:off x="2884405" y="3783295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D3061789-748D-4881-A4A1-8A4A0170D66E}"/>
                </a:ext>
              </a:extLst>
            </p:cNvPr>
            <p:cNvSpPr txBox="1"/>
            <p:nvPr/>
          </p:nvSpPr>
          <p:spPr>
            <a:xfrm>
              <a:off x="2942299" y="4416321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7D26152C-562A-4C95-BC42-2B7CA5D2D3BF}"/>
                </a:ext>
              </a:extLst>
            </p:cNvPr>
            <p:cNvSpPr txBox="1"/>
            <p:nvPr/>
          </p:nvSpPr>
          <p:spPr>
            <a:xfrm rot="3459587">
              <a:off x="1686388" y="2580890"/>
              <a:ext cx="5357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pper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87EFB9C4-E3B1-4F42-978C-A7F143880D36}"/>
                </a:ext>
              </a:extLst>
            </p:cNvPr>
            <p:cNvSpPr txBox="1"/>
            <p:nvPr/>
          </p:nvSpPr>
          <p:spPr>
            <a:xfrm rot="3459587">
              <a:off x="1921711" y="2561839"/>
              <a:ext cx="6142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ddle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C98F4A42-4072-4604-8ED2-C0BD8FFA640D}"/>
                </a:ext>
              </a:extLst>
            </p:cNvPr>
            <p:cNvSpPr txBox="1"/>
            <p:nvPr/>
          </p:nvSpPr>
          <p:spPr>
            <a:xfrm rot="3459587">
              <a:off x="2265151" y="2592895"/>
              <a:ext cx="5357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er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5DB68195-0725-493E-80AF-DDB8B9BD4779}"/>
                </a:ext>
              </a:extLst>
            </p:cNvPr>
            <p:cNvSpPr txBox="1"/>
            <p:nvPr/>
          </p:nvSpPr>
          <p:spPr>
            <a:xfrm>
              <a:off x="1938823" y="2143560"/>
              <a:ext cx="5838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poB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B3F4529E-AED0-4A61-A843-D92C8D0E3F07}"/>
                </a:ext>
              </a:extLst>
            </p:cNvPr>
            <p:cNvSpPr txBox="1"/>
            <p:nvPr/>
          </p:nvSpPr>
          <p:spPr>
            <a:xfrm>
              <a:off x="3759946" y="2157753"/>
              <a:ext cx="6832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poA1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1" name="図 20" descr="水, スキー, フィールド, 雪 が含まれている画像&#10;&#10;自動的に生成された説明">
              <a:extLst>
                <a:ext uri="{FF2B5EF4-FFF2-40B4-BE49-F238E27FC236}">
                  <a16:creationId xmlns:a16="http://schemas.microsoft.com/office/drawing/2014/main" id="{55501FF9-1174-4553-A91C-D0071C7B96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407" t="22667" r="56579" b="13570"/>
            <a:stretch/>
          </p:blipFill>
          <p:spPr>
            <a:xfrm>
              <a:off x="3644129" y="2957879"/>
              <a:ext cx="899588" cy="2492291"/>
            </a:xfrm>
            <a:prstGeom prst="rect">
              <a:avLst/>
            </a:prstGeom>
          </p:spPr>
        </p:pic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068DA389-7366-4820-B658-B763C9F8F052}"/>
                </a:ext>
              </a:extLst>
            </p:cNvPr>
            <p:cNvCxnSpPr/>
            <p:nvPr/>
          </p:nvCxnSpPr>
          <p:spPr>
            <a:xfrm>
              <a:off x="4564972" y="3611846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96FB6385-800D-4ADA-BEDE-06FD3BA8357C}"/>
                </a:ext>
              </a:extLst>
            </p:cNvPr>
            <p:cNvCxnSpPr/>
            <p:nvPr/>
          </p:nvCxnSpPr>
          <p:spPr>
            <a:xfrm>
              <a:off x="4564972" y="3926171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D82F8213-48C3-4B45-B5AE-E700B34B6C81}"/>
                </a:ext>
              </a:extLst>
            </p:cNvPr>
            <p:cNvCxnSpPr/>
            <p:nvPr/>
          </p:nvCxnSpPr>
          <p:spPr>
            <a:xfrm>
              <a:off x="4564972" y="4535771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14B04A8B-F37B-4C78-A195-878B1D187070}"/>
                </a:ext>
              </a:extLst>
            </p:cNvPr>
            <p:cNvSpPr txBox="1"/>
            <p:nvPr/>
          </p:nvSpPr>
          <p:spPr>
            <a:xfrm>
              <a:off x="4703680" y="3482871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0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39F4E1D7-B6E4-47E4-B2A6-8DBBA620270F}"/>
                </a:ext>
              </a:extLst>
            </p:cNvPr>
            <p:cNvSpPr txBox="1"/>
            <p:nvPr/>
          </p:nvSpPr>
          <p:spPr>
            <a:xfrm>
              <a:off x="4684630" y="3792820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EED517F6-5932-4232-BCE3-493C9CDE1D6D}"/>
                </a:ext>
              </a:extLst>
            </p:cNvPr>
            <p:cNvSpPr txBox="1"/>
            <p:nvPr/>
          </p:nvSpPr>
          <p:spPr>
            <a:xfrm>
              <a:off x="4742524" y="4416321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D2F7D0AF-064F-4209-A1B7-B7F61CAAC429}"/>
                </a:ext>
              </a:extLst>
            </p:cNvPr>
            <p:cNvSpPr txBox="1"/>
            <p:nvPr/>
          </p:nvSpPr>
          <p:spPr>
            <a:xfrm rot="3459587">
              <a:off x="3438988" y="2618990"/>
              <a:ext cx="5357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pper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2B61B4AB-CF1A-4476-887A-B68FE8FFDD1B}"/>
                </a:ext>
              </a:extLst>
            </p:cNvPr>
            <p:cNvSpPr txBox="1"/>
            <p:nvPr/>
          </p:nvSpPr>
          <p:spPr>
            <a:xfrm rot="3459587">
              <a:off x="3674311" y="2599939"/>
              <a:ext cx="6142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ddle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37318B05-74DD-4103-98D9-4472C51AE1A8}"/>
                </a:ext>
              </a:extLst>
            </p:cNvPr>
            <p:cNvSpPr txBox="1"/>
            <p:nvPr/>
          </p:nvSpPr>
          <p:spPr>
            <a:xfrm rot="3459587">
              <a:off x="4017751" y="2630995"/>
              <a:ext cx="5357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er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4" name="直線矢印コネクタ 33">
              <a:extLst>
                <a:ext uri="{FF2B5EF4-FFF2-40B4-BE49-F238E27FC236}">
                  <a16:creationId xmlns:a16="http://schemas.microsoft.com/office/drawing/2014/main" id="{1819F379-B498-44EB-9D1E-4DAA95D048BB}"/>
                </a:ext>
              </a:extLst>
            </p:cNvPr>
            <p:cNvCxnSpPr/>
            <p:nvPr/>
          </p:nvCxnSpPr>
          <p:spPr>
            <a:xfrm flipH="1">
              <a:off x="4564972" y="3097082"/>
              <a:ext cx="216000" cy="0"/>
            </a:xfrm>
            <a:prstGeom prst="straightConnector1">
              <a:avLst/>
            </a:prstGeom>
            <a:ln w="9525">
              <a:prstDash val="dash"/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A24B71A6-BE57-49C6-AC4D-BA6D8EDC91BA}"/>
                </a:ext>
              </a:extLst>
            </p:cNvPr>
            <p:cNvSpPr txBox="1"/>
            <p:nvPr/>
          </p:nvSpPr>
          <p:spPr>
            <a:xfrm>
              <a:off x="4715151" y="2941666"/>
              <a:ext cx="87876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n-specific</a:t>
              </a:r>
              <a:endPara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BF2DD256-794A-4CC2-B943-3E3D533E38B5}"/>
                </a:ext>
              </a:extLst>
            </p:cNvPr>
            <p:cNvSpPr txBox="1"/>
            <p:nvPr/>
          </p:nvSpPr>
          <p:spPr>
            <a:xfrm>
              <a:off x="2734536" y="3146077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144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m</a:t>
              </a:r>
              <a:r>
                <a:rPr kumimoji="1" lang="en-US" altLang="ja-JP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/</a:t>
              </a:r>
              <a:r>
                <a:rPr kumimoji="1" lang="en-US" altLang="ja-JP" sz="10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kDa</a:t>
              </a:r>
              <a:endParaRPr kumimoji="1" lang="ja-JP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215E2886-68A6-4A89-98AA-F6E650752BDB}"/>
                </a:ext>
              </a:extLst>
            </p:cNvPr>
            <p:cNvSpPr txBox="1"/>
            <p:nvPr/>
          </p:nvSpPr>
          <p:spPr>
            <a:xfrm>
              <a:off x="4510705" y="3188698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144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m</a:t>
              </a:r>
              <a:r>
                <a:rPr kumimoji="1" lang="en-US" altLang="ja-JP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/</a:t>
              </a:r>
              <a:r>
                <a:rPr kumimoji="1" lang="en-US" altLang="ja-JP" sz="10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kDa</a:t>
              </a:r>
              <a:endParaRPr kumimoji="1" lang="ja-JP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E77ACCA-8298-4A60-AD5A-A7B022FF2FCA}"/>
              </a:ext>
            </a:extLst>
          </p:cNvPr>
          <p:cNvSpPr txBox="1"/>
          <p:nvPr/>
        </p:nvSpPr>
        <p:spPr>
          <a:xfrm>
            <a:off x="238697" y="148221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Supplementary Figure S1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B3B10C2-0E13-416C-BB2F-73FCBA425A9A}"/>
              </a:ext>
            </a:extLst>
          </p:cNvPr>
          <p:cNvSpPr txBox="1"/>
          <p:nvPr/>
        </p:nvSpPr>
        <p:spPr>
          <a:xfrm>
            <a:off x="438150" y="5165872"/>
            <a:ext cx="577215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igure S1.  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elective recovery</a:t>
            </a:r>
            <a:r>
              <a:rPr kumimoji="0" lang="en-US" altLang="ja-JP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of LDL and HDL by ultracentrifugation. After incubating LDL (100 </a:t>
            </a:r>
            <a:r>
              <a:rPr kumimoji="0" lang="en-US" altLang="ja-JP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anose="05050102010706020507" pitchFamily="18" charset="2"/>
                <a:ea typeface="游ゴシック" panose="020B0400000000000000" pitchFamily="50" charset="-128"/>
                <a:cs typeface="Times New Roman" panose="02020603050405020304" pitchFamily="18" charset="0"/>
              </a:rPr>
              <a:t>m</a:t>
            </a:r>
            <a:r>
              <a:rPr kumimoji="0" lang="en-US" altLang="ja-JP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g) and HDL (100 </a:t>
            </a:r>
            <a:r>
              <a:rPr kumimoji="0" lang="en-US" altLang="ja-JP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anose="05050102010706020507" pitchFamily="18" charset="2"/>
                <a:ea typeface="游ゴシック" panose="020B0400000000000000" pitchFamily="50" charset="-128"/>
                <a:cs typeface="Times New Roman" panose="02020603050405020304" pitchFamily="18" charset="0"/>
              </a:rPr>
              <a:t>m</a:t>
            </a:r>
            <a:r>
              <a:rPr kumimoji="0" lang="en-US" altLang="ja-JP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g) for 2 h (total volume 0.5 mL), they were separated by ultracentrifugation after adjusting d=1.063 using KBr. 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he</a:t>
            </a:r>
            <a:r>
              <a:rPr kumimoji="0" lang="en-US" altLang="ja-JP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sample was fraction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t</a:t>
            </a:r>
            <a:r>
              <a:rPr kumimoji="0" lang="en-US" altLang="ja-JP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d into upper, middle, and lower fractions. The distribution of </a:t>
            </a:r>
            <a:r>
              <a:rPr kumimoji="0" lang="en-US" altLang="ja-JP" sz="12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poB</a:t>
            </a:r>
            <a:r>
              <a:rPr kumimoji="0" lang="en-US" altLang="ja-JP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and apoA1 was examined by western blotting. Each lane was loaded with 3 </a:t>
            </a:r>
            <a:r>
              <a:rPr lang="en-US" altLang="ja-JP" sz="1200" dirty="0">
                <a:solidFill>
                  <a:prstClr val="black"/>
                </a:solidFill>
                <a:latin typeface="Symbol" panose="05050102010706020507" pitchFamily="18" charset="2"/>
                <a:ea typeface="游ゴシック" panose="020B0400000000000000" pitchFamily="50" charset="-128"/>
                <a:cs typeface="Times New Roman" panose="02020603050405020304" pitchFamily="18" charset="0"/>
              </a:rPr>
              <a:t>m</a:t>
            </a:r>
            <a:r>
              <a:rPr kumimoji="0" lang="en-US" altLang="ja-JP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g protein of the samples. After blotting with anti-</a:t>
            </a:r>
            <a:r>
              <a:rPr kumimoji="0" lang="en-US" altLang="ja-JP" sz="12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poB</a:t>
            </a:r>
            <a:r>
              <a:rPr kumimoji="0" lang="en-US" altLang="ja-JP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antibody, the same membraned was </a:t>
            </a:r>
            <a:r>
              <a:rPr kumimoji="0" lang="en-US" altLang="ja-JP" sz="12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reprobed</a:t>
            </a:r>
            <a:r>
              <a:rPr kumimoji="0" lang="en-US" altLang="ja-JP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with anti-apoA1 antibody. 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he middle fraction contained both </a:t>
            </a:r>
            <a:r>
              <a:rPr lang="en-US" altLang="ja-JP" sz="1200" dirty="0" err="1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poB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and apoA1, however, the amounts of </a:t>
            </a:r>
            <a:r>
              <a:rPr lang="en-US" altLang="ja-JP" sz="1200" dirty="0" err="1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poB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in the lower fraction and apoA1 in the upper </a:t>
            </a:r>
            <a:r>
              <a:rPr lang="en-US" altLang="ja-JP" sz="120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raction were 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inimal, if any.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95149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821</TotalTime>
  <Words>154</Words>
  <Application>Microsoft Office PowerPoint</Application>
  <PresentationFormat>A4 210 x 297 mm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ko Sawada</dc:creator>
  <cp:lastModifiedBy>洋之 板部</cp:lastModifiedBy>
  <cp:revision>381</cp:revision>
  <cp:lastPrinted>2020-07-10T03:22:08Z</cp:lastPrinted>
  <dcterms:created xsi:type="dcterms:W3CDTF">2019-07-30T06:22:56Z</dcterms:created>
  <dcterms:modified xsi:type="dcterms:W3CDTF">2020-10-10T03:21:09Z</dcterms:modified>
</cp:coreProperties>
</file>